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113" d="100"/>
          <a:sy n="113" d="100"/>
        </p:scale>
        <p:origin x="456" y="10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-Arbeitsblatt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-Arbeitsblat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bar"/>
        <c:grouping val="clustered"/>
        <c:varyColors val="0"/>
        <c:ser>
          <c:idx val="0"/>
          <c:order val="0"/>
          <c:spPr>
            <a:solidFill>
              <a:schemeClr val="tx1">
                <a:lumMod val="75000"/>
                <a:lumOff val="250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7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de-DE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c vs o sum 9'!$U$4:$U$18</c:f>
              <c:strCache>
                <c:ptCount val="15"/>
                <c:pt idx="0">
                  <c:v>Composite dishes, n=21</c:v>
                </c:pt>
                <c:pt idx="1">
                  <c:v>Products for non-standard diets and food imitates (tofu)</c:v>
                </c:pt>
                <c:pt idx="2">
                  <c:v>Food products for infants and toddlers, n=4</c:v>
                </c:pt>
                <c:pt idx="3">
                  <c:v>Alcoholic beverages, n=3</c:v>
                </c:pt>
                <c:pt idx="4">
                  <c:v>Coffee, cocoa, tea and infusions, n=2</c:v>
                </c:pt>
                <c:pt idx="5">
                  <c:v>Animal and vegetable fats and oils, n=4</c:v>
                </c:pt>
                <c:pt idx="6">
                  <c:v>Sugar, confectionery and water-based sweet desserts, n=2</c:v>
                </c:pt>
                <c:pt idx="7">
                  <c:v>Eggs and egg products, n=2</c:v>
                </c:pt>
                <c:pt idx="8">
                  <c:v>Milk and dairy products, n=7</c:v>
                </c:pt>
                <c:pt idx="9">
                  <c:v>Meat and meat products, n=12</c:v>
                </c:pt>
                <c:pt idx="10">
                  <c:v>Fruit and fruit products, n=2</c:v>
                </c:pt>
                <c:pt idx="11">
                  <c:v>Legumes, nuts, oilseeds and spices, n=4</c:v>
                </c:pt>
                <c:pt idx="12">
                  <c:v>Starchy roots or tubers and products thereof, n=2</c:v>
                </c:pt>
                <c:pt idx="13">
                  <c:v>Vegetables and vegetable products, n=7</c:v>
                </c:pt>
                <c:pt idx="14">
                  <c:v>Grains and grain-based products, n=14</c:v>
                </c:pt>
              </c:strCache>
            </c:strRef>
          </c:cat>
          <c:val>
            <c:numRef>
              <c:f>'c vs o sum 9'!$V$4:$V$18</c:f>
              <c:numCache>
                <c:formatCode>0.00</c:formatCode>
                <c:ptCount val="15"/>
                <c:pt idx="0" formatCode="0.0">
                  <c:v>27.584749999999996</c:v>
                </c:pt>
                <c:pt idx="1">
                  <c:v>2.12</c:v>
                </c:pt>
                <c:pt idx="2" formatCode="0.0">
                  <c:v>3.6987087499999998</c:v>
                </c:pt>
                <c:pt idx="3">
                  <c:v>0.80000000000000016</c:v>
                </c:pt>
                <c:pt idx="4">
                  <c:v>2.16</c:v>
                </c:pt>
                <c:pt idx="5" formatCode="0.0">
                  <c:v>21.113500000000002</c:v>
                </c:pt>
                <c:pt idx="6" formatCode="0.0">
                  <c:v>4.9652000000000003</c:v>
                </c:pt>
                <c:pt idx="7" formatCode="0.0">
                  <c:v>12.598166666666668</c:v>
                </c:pt>
                <c:pt idx="8" formatCode="0.0">
                  <c:v>10.053507142857143</c:v>
                </c:pt>
                <c:pt idx="9" formatCode="0.0">
                  <c:v>31.44169444444444</c:v>
                </c:pt>
                <c:pt idx="10">
                  <c:v>2.29</c:v>
                </c:pt>
                <c:pt idx="11" formatCode="0.0">
                  <c:v>12.9064675</c:v>
                </c:pt>
                <c:pt idx="12">
                  <c:v>4.2424999999999997</c:v>
                </c:pt>
                <c:pt idx="13" formatCode="0.0">
                  <c:v>3.1935523809523816</c:v>
                </c:pt>
                <c:pt idx="14" formatCode="0.0">
                  <c:v>6.531473214285716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040-4B1F-AD59-67C2A95BADFC}"/>
            </c:ext>
          </c:extLst>
        </c:ser>
        <c:ser>
          <c:idx val="1"/>
          <c:order val="1"/>
          <c:spPr>
            <a:solidFill>
              <a:schemeClr val="bg1">
                <a:lumMod val="75000"/>
              </a:schemeClr>
            </a:solidFill>
            <a:ln>
              <a:noFill/>
            </a:ln>
            <a:effectLst/>
          </c:spPr>
          <c:invertIfNegative val="0"/>
          <c:dLbls>
            <c:dLbl>
              <c:idx val="9"/>
              <c:numFmt formatCode="#,##0.0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0" i="0" u="none" strike="noStrike" kern="120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de-DE"/>
                </a:p>
              </c:txPr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6="http://schemas.microsoft.com/office/drawing/2014/chart" uri="{C3380CC4-5D6E-409C-BE32-E72D297353CC}">
                  <c16:uniqueId val="{00000001-3040-4B1F-AD59-67C2A95BADFC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7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de-DE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c vs o sum 9'!$U$4:$U$18</c:f>
              <c:strCache>
                <c:ptCount val="15"/>
                <c:pt idx="0">
                  <c:v>Composite dishes, n=21</c:v>
                </c:pt>
                <c:pt idx="1">
                  <c:v>Products for non-standard diets and food imitates (tofu)</c:v>
                </c:pt>
                <c:pt idx="2">
                  <c:v>Food products for infants and toddlers, n=4</c:v>
                </c:pt>
                <c:pt idx="3">
                  <c:v>Alcoholic beverages, n=3</c:v>
                </c:pt>
                <c:pt idx="4">
                  <c:v>Coffee, cocoa, tea and infusions, n=2</c:v>
                </c:pt>
                <c:pt idx="5">
                  <c:v>Animal and vegetable fats and oils, n=4</c:v>
                </c:pt>
                <c:pt idx="6">
                  <c:v>Sugar, confectionery and water-based sweet desserts, n=2</c:v>
                </c:pt>
                <c:pt idx="7">
                  <c:v>Eggs and egg products, n=2</c:v>
                </c:pt>
                <c:pt idx="8">
                  <c:v>Milk and dairy products, n=7</c:v>
                </c:pt>
                <c:pt idx="9">
                  <c:v>Meat and meat products, n=12</c:v>
                </c:pt>
                <c:pt idx="10">
                  <c:v>Fruit and fruit products, n=2</c:v>
                </c:pt>
                <c:pt idx="11">
                  <c:v>Legumes, nuts, oilseeds and spices, n=4</c:v>
                </c:pt>
                <c:pt idx="12">
                  <c:v>Starchy roots or tubers and products thereof, n=2</c:v>
                </c:pt>
                <c:pt idx="13">
                  <c:v>Vegetables and vegetable products, n=7</c:v>
                </c:pt>
                <c:pt idx="14">
                  <c:v>Grains and grain-based products, n=14</c:v>
                </c:pt>
              </c:strCache>
            </c:strRef>
          </c:cat>
          <c:val>
            <c:numRef>
              <c:f>'c vs o sum 9'!$W$4:$W$18</c:f>
              <c:numCache>
                <c:formatCode>0.00</c:formatCode>
                <c:ptCount val="15"/>
                <c:pt idx="0" formatCode="0.0">
                  <c:v>7.5879339285714282</c:v>
                </c:pt>
                <c:pt idx="1">
                  <c:v>2.1199999999999997</c:v>
                </c:pt>
                <c:pt idx="2" formatCode="0.0">
                  <c:v>6.5603712500000011</c:v>
                </c:pt>
                <c:pt idx="3">
                  <c:v>0.9966666666666667</c:v>
                </c:pt>
                <c:pt idx="4">
                  <c:v>3.1047500000000001</c:v>
                </c:pt>
                <c:pt idx="5" formatCode="0.0">
                  <c:v>22.145899999999997</c:v>
                </c:pt>
                <c:pt idx="6" formatCode="0">
                  <c:v>10.368925000000001</c:v>
                </c:pt>
                <c:pt idx="7" formatCode="0.0">
                  <c:v>19.693783333333332</c:v>
                </c:pt>
                <c:pt idx="8" formatCode="0.0">
                  <c:v>12.362457142857144</c:v>
                </c:pt>
                <c:pt idx="9" formatCode="0.0">
                  <c:v>57.418053958333331</c:v>
                </c:pt>
                <c:pt idx="10">
                  <c:v>1.9499999999999997</c:v>
                </c:pt>
                <c:pt idx="11" formatCode="0.0">
                  <c:v>8.3505075000000009</c:v>
                </c:pt>
                <c:pt idx="12">
                  <c:v>4.0875000000000004</c:v>
                </c:pt>
                <c:pt idx="13" formatCode="0.0">
                  <c:v>3.2454573809523803</c:v>
                </c:pt>
                <c:pt idx="14" formatCode="0.0">
                  <c:v>6.377210714285715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3040-4B1F-AD59-67C2A95BADF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680712272"/>
        <c:axId val="680716864"/>
      </c:barChart>
      <c:catAx>
        <c:axId val="680712272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de-DE"/>
          </a:p>
        </c:txPr>
        <c:crossAx val="680716864"/>
        <c:crosses val="autoZero"/>
        <c:auto val="1"/>
        <c:lblAlgn val="ctr"/>
        <c:lblOffset val="100"/>
        <c:noMultiLvlLbl val="0"/>
      </c:catAx>
      <c:valAx>
        <c:axId val="680716864"/>
        <c:scaling>
          <c:orientation val="minMax"/>
          <c:max val="60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de-DE" sz="800" dirty="0" err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ean</a:t>
                </a:r>
                <a:r>
                  <a:rPr lang="de-DE" sz="8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UB </a:t>
                </a:r>
                <a:r>
                  <a:rPr lang="de-DE" sz="800" dirty="0" err="1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evels</a:t>
                </a:r>
                <a:r>
                  <a:rPr lang="de-DE" sz="800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∑9 </a:t>
                </a:r>
                <a:r>
                  <a:rPr lang="de-DE" sz="8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BDEs (</a:t>
                </a:r>
                <a:r>
                  <a:rPr lang="de-DE" sz="800" dirty="0" err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g</a:t>
                </a:r>
                <a:r>
                  <a:rPr lang="de-DE" sz="800" baseline="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/g </a:t>
                </a:r>
                <a:r>
                  <a:rPr lang="de-DE" sz="800" baseline="0" dirty="0" err="1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et</a:t>
                </a:r>
                <a:r>
                  <a:rPr lang="de-DE" sz="800" baseline="0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de-DE" sz="800" baseline="0" dirty="0" err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eight</a:t>
                </a:r>
                <a:r>
                  <a:rPr lang="de-DE" sz="800" baseline="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  <a:endParaRPr lang="de-DE" sz="8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0.53046967945805201"/>
              <c:y val="0.94236997243397957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de-DE"/>
          </a:p>
        </c:txPr>
        <c:crossAx val="680712272"/>
        <c:crosses val="autoZero"/>
        <c:crossBetween val="between"/>
        <c:majorUnit val="10"/>
      </c:valAx>
    </c:plotArea>
    <c:plotVisOnly val="1"/>
    <c:dispBlanksAs val="gap"/>
    <c:showDLblsOverMax val="0"/>
  </c:chart>
  <c:txPr>
    <a:bodyPr/>
    <a:lstStyle/>
    <a:p>
      <a:pPr>
        <a:defRPr/>
      </a:pPr>
      <a:endParaRPr lang="de-DE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bar"/>
        <c:grouping val="clustered"/>
        <c:varyColors val="0"/>
        <c:ser>
          <c:idx val="0"/>
          <c:order val="0"/>
          <c:spPr>
            <a:solidFill>
              <a:schemeClr val="tx1">
                <a:lumMod val="75000"/>
                <a:lumOff val="250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7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de-DE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c vs o sum 10'!$U$4:$U$18</c:f>
              <c:strCache>
                <c:ptCount val="15"/>
                <c:pt idx="0">
                  <c:v>Composite dishes, n=21</c:v>
                </c:pt>
                <c:pt idx="1">
                  <c:v>Products for non-standard diets and food imitates (tofu)</c:v>
                </c:pt>
                <c:pt idx="2">
                  <c:v>Food products for infants and toddlers, n=4</c:v>
                </c:pt>
                <c:pt idx="3">
                  <c:v>Alcoholic beverages, n=3</c:v>
                </c:pt>
                <c:pt idx="4">
                  <c:v>Coffee, cocoa, tea and infusions, n=2</c:v>
                </c:pt>
                <c:pt idx="5">
                  <c:v>Animal and vegetable fats and oils, n=4</c:v>
                </c:pt>
                <c:pt idx="6">
                  <c:v>Sugar, confectionery and water-based sweet desserts, n=2</c:v>
                </c:pt>
                <c:pt idx="7">
                  <c:v>Eggs and egg products, n=2</c:v>
                </c:pt>
                <c:pt idx="8">
                  <c:v>Milk and dairy products, n=7</c:v>
                </c:pt>
                <c:pt idx="9">
                  <c:v>Meat and meat products, n=12</c:v>
                </c:pt>
                <c:pt idx="10">
                  <c:v>Fruit and fruit products, n=2</c:v>
                </c:pt>
                <c:pt idx="11">
                  <c:v>Legumes, nuts, oilseeds and spices, n=4</c:v>
                </c:pt>
                <c:pt idx="12">
                  <c:v>Starchy roots or tubers and products thereof, n=2</c:v>
                </c:pt>
                <c:pt idx="13">
                  <c:v>Vegetables and vegetable products, n=7</c:v>
                </c:pt>
                <c:pt idx="14">
                  <c:v>Grains and grain-based products, n=14</c:v>
                </c:pt>
              </c:strCache>
            </c:strRef>
          </c:cat>
          <c:val>
            <c:numRef>
              <c:f>'c vs o sum 10'!$V$4:$V$18</c:f>
              <c:numCache>
                <c:formatCode>0.00</c:formatCode>
                <c:ptCount val="15"/>
                <c:pt idx="0" formatCode="0.0">
                  <c:v>46.005911904761909</c:v>
                </c:pt>
                <c:pt idx="1">
                  <c:v>3.12</c:v>
                </c:pt>
                <c:pt idx="2" formatCode="0.0">
                  <c:v>21.23345875</c:v>
                </c:pt>
                <c:pt idx="3">
                  <c:v>3.0566666666666666</c:v>
                </c:pt>
                <c:pt idx="4">
                  <c:v>3.5350000000000001</c:v>
                </c:pt>
                <c:pt idx="5" formatCode="0.0">
                  <c:v>69.210583333333332</c:v>
                </c:pt>
                <c:pt idx="6" formatCode="0.0">
                  <c:v>57.927699999999994</c:v>
                </c:pt>
                <c:pt idx="7" formatCode="0.0">
                  <c:v>76.214833333333331</c:v>
                </c:pt>
                <c:pt idx="8" formatCode="0.0">
                  <c:v>16.455650000000002</c:v>
                </c:pt>
                <c:pt idx="9" formatCode="0.0">
                  <c:v>47.275305555555555</c:v>
                </c:pt>
                <c:pt idx="10">
                  <c:v>4.04</c:v>
                </c:pt>
                <c:pt idx="11" formatCode="0.0">
                  <c:v>88.995677499999999</c:v>
                </c:pt>
                <c:pt idx="12">
                  <c:v>7.6050000000000004</c:v>
                </c:pt>
                <c:pt idx="13" formatCode="0.0">
                  <c:v>12.567957142857143</c:v>
                </c:pt>
                <c:pt idx="14" formatCode="0.0">
                  <c:v>41.29950464285715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100-4A54-BD66-E8BA45B5EEA4}"/>
            </c:ext>
          </c:extLst>
        </c:ser>
        <c:ser>
          <c:idx val="1"/>
          <c:order val="1"/>
          <c:spPr>
            <a:solidFill>
              <a:schemeClr val="bg1">
                <a:lumMod val="75000"/>
              </a:schemeClr>
            </a:solidFill>
            <a:ln>
              <a:noFill/>
            </a:ln>
            <a:effectLst/>
          </c:spPr>
          <c:invertIfNegative val="0"/>
          <c:dLbls>
            <c:dLbl>
              <c:idx val="9"/>
              <c:numFmt formatCode="#,##0.0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0" i="0" u="none" strike="noStrike" kern="120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de-DE"/>
                </a:p>
              </c:txPr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6="http://schemas.microsoft.com/office/drawing/2014/chart" uri="{C3380CC4-5D6E-409C-BE32-E72D297353CC}">
                  <c16:uniqueId val="{00000001-9100-4A54-BD66-E8BA45B5EEA4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7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de-DE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c vs o sum 10'!$U$4:$U$18</c:f>
              <c:strCache>
                <c:ptCount val="15"/>
                <c:pt idx="0">
                  <c:v>Composite dishes, n=21</c:v>
                </c:pt>
                <c:pt idx="1">
                  <c:v>Products for non-standard diets and food imitates (tofu)</c:v>
                </c:pt>
                <c:pt idx="2">
                  <c:v>Food products for infants and toddlers, n=4</c:v>
                </c:pt>
                <c:pt idx="3">
                  <c:v>Alcoholic beverages, n=3</c:v>
                </c:pt>
                <c:pt idx="4">
                  <c:v>Coffee, cocoa, tea and infusions, n=2</c:v>
                </c:pt>
                <c:pt idx="5">
                  <c:v>Animal and vegetable fats and oils, n=4</c:v>
                </c:pt>
                <c:pt idx="6">
                  <c:v>Sugar, confectionery and water-based sweet desserts, n=2</c:v>
                </c:pt>
                <c:pt idx="7">
                  <c:v>Eggs and egg products, n=2</c:v>
                </c:pt>
                <c:pt idx="8">
                  <c:v>Milk and dairy products, n=7</c:v>
                </c:pt>
                <c:pt idx="9">
                  <c:v>Meat and meat products, n=12</c:v>
                </c:pt>
                <c:pt idx="10">
                  <c:v>Fruit and fruit products, n=2</c:v>
                </c:pt>
                <c:pt idx="11">
                  <c:v>Legumes, nuts, oilseeds and spices, n=4</c:v>
                </c:pt>
                <c:pt idx="12">
                  <c:v>Starchy roots or tubers and products thereof, n=2</c:v>
                </c:pt>
                <c:pt idx="13">
                  <c:v>Vegetables and vegetable products, n=7</c:v>
                </c:pt>
                <c:pt idx="14">
                  <c:v>Grains and grain-based products, n=14</c:v>
                </c:pt>
              </c:strCache>
            </c:strRef>
          </c:cat>
          <c:val>
            <c:numRef>
              <c:f>'c vs o sum 10'!$W$4:$W$18</c:f>
              <c:numCache>
                <c:formatCode>0.00</c:formatCode>
                <c:ptCount val="15"/>
                <c:pt idx="0" formatCode="0.0">
                  <c:v>19.984288095238099</c:v>
                </c:pt>
                <c:pt idx="1">
                  <c:v>3.1199999999999997</c:v>
                </c:pt>
                <c:pt idx="2" formatCode="0.0">
                  <c:v>19.470371249999999</c:v>
                </c:pt>
                <c:pt idx="3">
                  <c:v>4.4800000000000004</c:v>
                </c:pt>
                <c:pt idx="4">
                  <c:v>6.0897500000000004</c:v>
                </c:pt>
                <c:pt idx="5" formatCode="0.0">
                  <c:v>60.524649999999994</c:v>
                </c:pt>
                <c:pt idx="6" formatCode="0">
                  <c:v>157.43892499999998</c:v>
                </c:pt>
                <c:pt idx="7" formatCode="0.0">
                  <c:v>56.958783333333329</c:v>
                </c:pt>
                <c:pt idx="8" formatCode="0.0">
                  <c:v>20.198185714285717</c:v>
                </c:pt>
                <c:pt idx="9" formatCode="0.0">
                  <c:v>73.059920833333322</c:v>
                </c:pt>
                <c:pt idx="10">
                  <c:v>3.7</c:v>
                </c:pt>
                <c:pt idx="11" formatCode="0.0">
                  <c:v>85.265514999999994</c:v>
                </c:pt>
                <c:pt idx="12">
                  <c:v>9.254999999999999</c:v>
                </c:pt>
                <c:pt idx="13" formatCode="0.0">
                  <c:v>21.400457380952382</c:v>
                </c:pt>
                <c:pt idx="14" formatCode="0.0">
                  <c:v>46.7457169047618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9100-4A54-BD66-E8BA45B5EEA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680712272"/>
        <c:axId val="680716864"/>
      </c:barChart>
      <c:catAx>
        <c:axId val="680712272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de-DE"/>
          </a:p>
        </c:txPr>
        <c:crossAx val="680716864"/>
        <c:crosses val="autoZero"/>
        <c:auto val="1"/>
        <c:lblAlgn val="ctr"/>
        <c:lblOffset val="100"/>
        <c:noMultiLvlLbl val="0"/>
      </c:catAx>
      <c:valAx>
        <c:axId val="680716864"/>
        <c:scaling>
          <c:orientation val="minMax"/>
          <c:max val="180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de-DE" sz="800" dirty="0" err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ean</a:t>
                </a:r>
                <a:r>
                  <a:rPr lang="de-DE" sz="8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UB </a:t>
                </a:r>
                <a:r>
                  <a:rPr lang="de-DE" sz="800" dirty="0" err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evels</a:t>
                </a:r>
                <a:r>
                  <a:rPr lang="de-DE" sz="8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de-DE" sz="800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∑10 </a:t>
                </a:r>
                <a:r>
                  <a:rPr lang="de-DE" sz="8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BDEs (</a:t>
                </a:r>
                <a:r>
                  <a:rPr lang="de-DE" sz="800" dirty="0" err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g</a:t>
                </a:r>
                <a:r>
                  <a:rPr lang="de-DE" sz="800" baseline="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/g </a:t>
                </a:r>
                <a:r>
                  <a:rPr lang="de-DE" sz="800" baseline="0" dirty="0" err="1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et</a:t>
                </a:r>
                <a:r>
                  <a:rPr lang="de-DE" sz="800" baseline="0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de-DE" sz="800" baseline="0" dirty="0" err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eight</a:t>
                </a:r>
                <a:r>
                  <a:rPr lang="de-DE" sz="800" baseline="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  <a:endParaRPr lang="de-DE" sz="8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0.53468542596408897"/>
              <c:y val="0.9399155860671593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de-DE"/>
          </a:p>
        </c:txPr>
        <c:crossAx val="680712272"/>
        <c:crosses val="autoZero"/>
        <c:crossBetween val="between"/>
        <c:majorUnit val="20"/>
      </c:valAx>
    </c:plotArea>
    <c:plotVisOnly val="1"/>
    <c:dispBlanksAs val="gap"/>
    <c:showDLblsOverMax val="0"/>
  </c:chart>
  <c:txPr>
    <a:bodyPr/>
    <a:lstStyle/>
    <a:p>
      <a:pPr>
        <a:defRPr/>
      </a:pPr>
      <a:endParaRPr lang="de-DE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8B8A5E-7D03-45D4-B765-78C079287ACA}" type="datetimeFigureOut">
              <a:rPr lang="de-DE" smtClean="0"/>
              <a:t>08.08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EAAD6-8003-4362-9CF7-E651F277FA9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160252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8B8A5E-7D03-45D4-B765-78C079287ACA}" type="datetimeFigureOut">
              <a:rPr lang="de-DE" smtClean="0"/>
              <a:t>08.08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EAAD6-8003-4362-9CF7-E651F277FA9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254711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8B8A5E-7D03-45D4-B765-78C079287ACA}" type="datetimeFigureOut">
              <a:rPr lang="de-DE" smtClean="0"/>
              <a:t>08.08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EAAD6-8003-4362-9CF7-E651F277FA9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136304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8B8A5E-7D03-45D4-B765-78C079287ACA}" type="datetimeFigureOut">
              <a:rPr lang="de-DE" smtClean="0"/>
              <a:t>08.08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EAAD6-8003-4362-9CF7-E651F277FA9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671011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8B8A5E-7D03-45D4-B765-78C079287ACA}" type="datetimeFigureOut">
              <a:rPr lang="de-DE" smtClean="0"/>
              <a:t>08.08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EAAD6-8003-4362-9CF7-E651F277FA9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982349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8B8A5E-7D03-45D4-B765-78C079287ACA}" type="datetimeFigureOut">
              <a:rPr lang="de-DE" smtClean="0"/>
              <a:t>08.08.202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EAAD6-8003-4362-9CF7-E651F277FA9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173663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8B8A5E-7D03-45D4-B765-78C079287ACA}" type="datetimeFigureOut">
              <a:rPr lang="de-DE" smtClean="0"/>
              <a:t>08.08.2023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EAAD6-8003-4362-9CF7-E651F277FA9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819438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8B8A5E-7D03-45D4-B765-78C079287ACA}" type="datetimeFigureOut">
              <a:rPr lang="de-DE" smtClean="0"/>
              <a:t>08.08.2023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EAAD6-8003-4362-9CF7-E651F277FA9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057211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8B8A5E-7D03-45D4-B765-78C079287ACA}" type="datetimeFigureOut">
              <a:rPr lang="de-DE" smtClean="0"/>
              <a:t>08.08.2023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EAAD6-8003-4362-9CF7-E651F277FA9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239998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8B8A5E-7D03-45D4-B765-78C079287ACA}" type="datetimeFigureOut">
              <a:rPr lang="de-DE" smtClean="0"/>
              <a:t>08.08.202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EAAD6-8003-4362-9CF7-E651F277FA9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614747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8B8A5E-7D03-45D4-B765-78C079287ACA}" type="datetimeFigureOut">
              <a:rPr lang="de-DE" smtClean="0"/>
              <a:t>08.08.202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EAAD6-8003-4362-9CF7-E651F277FA9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24338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8B8A5E-7D03-45D4-B765-78C079287ACA}" type="datetimeFigureOut">
              <a:rPr lang="de-DE" smtClean="0"/>
              <a:t>08.08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DEAAD6-8003-4362-9CF7-E651F277FA9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562479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Diagramm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87313133"/>
              </p:ext>
            </p:extLst>
          </p:nvPr>
        </p:nvGraphicFramePr>
        <p:xfrm>
          <a:off x="540839" y="1337071"/>
          <a:ext cx="5436968" cy="417962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Rechteck 2"/>
          <p:cNvSpPr/>
          <p:nvPr/>
        </p:nvSpPr>
        <p:spPr>
          <a:xfrm>
            <a:off x="643463" y="5653089"/>
            <a:ext cx="11313406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1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3: </a:t>
            </a:r>
            <a:r>
              <a:rPr lang="en-US" sz="11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A) Mean upper bound (UB</a:t>
            </a:r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sz="11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evels of </a:t>
            </a:r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e sum of </a:t>
            </a:r>
            <a:r>
              <a:rPr lang="en-US" sz="11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ine PBDEs </a:t>
            </a:r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1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ithout BDE-209) in MEAL food groups according to conventional and organic type of production and (B</a:t>
            </a:r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sz="11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ean UB </a:t>
            </a:r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evels of the sum of </a:t>
            </a:r>
            <a:r>
              <a:rPr lang="en-US" sz="11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en PBDEs (including BDE-209</a:t>
            </a:r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. Data are means (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 reflects the number of MEAL foods</a:t>
            </a:r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.</a:t>
            </a:r>
            <a:endParaRPr lang="de-DE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4" name="Diagramm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88732418"/>
              </p:ext>
            </p:extLst>
          </p:nvPr>
        </p:nvGraphicFramePr>
        <p:xfrm>
          <a:off x="6200502" y="1331229"/>
          <a:ext cx="5525924" cy="417959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" name="Textfeld 4"/>
          <p:cNvSpPr txBox="1"/>
          <p:nvPr/>
        </p:nvSpPr>
        <p:spPr>
          <a:xfrm>
            <a:off x="404284" y="1182476"/>
            <a:ext cx="59218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de-DE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feld 5"/>
          <p:cNvSpPr txBox="1"/>
          <p:nvPr/>
        </p:nvSpPr>
        <p:spPr>
          <a:xfrm>
            <a:off x="6051801" y="1188318"/>
            <a:ext cx="59218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de-DE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" name="Grafik 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243519" y="1473460"/>
            <a:ext cx="703774" cy="50628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146402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0</Words>
  <Application>Microsoft Office PowerPoint</Application>
  <PresentationFormat>Breitbild</PresentationFormat>
  <Paragraphs>7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</vt:lpstr>
      <vt:lpstr>PowerPoint-Präsentation</vt:lpstr>
    </vt:vector>
  </TitlesOfParts>
  <Company>Bundesinstitut für Risikobewertung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Frau Dr. Mandy Stadion</dc:creator>
  <cp:lastModifiedBy>Frau Dr. Mandy Stadion</cp:lastModifiedBy>
  <cp:revision>7</cp:revision>
  <dcterms:created xsi:type="dcterms:W3CDTF">2023-04-18T12:32:39Z</dcterms:created>
  <dcterms:modified xsi:type="dcterms:W3CDTF">2023-08-08T10:18:03Z</dcterms:modified>
</cp:coreProperties>
</file>